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EDCD950-B74C-4966-ACD9-7B4B6360E32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CF15A3-CAC2-4EB1-9351-B36A5B948E3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928F08-CBCB-490A-BB40-CDD3040078E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2AE336-9E0B-4810-830E-D4CAA5933A3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A642C5-4603-49F2-ABCC-7CDF16E746D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8D0B53F-75C3-4B58-9C15-841A1B37F07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41FE0A2-B66A-420A-8ECB-EE74281969B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5AE407C-1D08-4058-9C72-6020F5D4143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A6F2AE2-B7CC-4D43-A31E-2303DC0A0F7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4D635-08B2-4216-B0DC-4F06ED6C8D7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602B46-8F53-49BB-A387-4A1FE25235D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587C801-95BD-4980-80E2-66D5081B432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B6291BA0-1B92-4462-AEFF-60B5769EDBFE}" type="datetime">
              <a:rPr b="0" lang="ja-JP" sz="1200" spc="-1" strike="noStrike">
                <a:solidFill>
                  <a:srgbClr val="898989"/>
                </a:solidFill>
                <a:latin typeface="Calibri"/>
              </a:rPr>
              <a:t>26/08/29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ja-JP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1D268894-A2D4-40EB-B5D1-2E8E9FE5CDE5}" type="slidenum">
              <a:rPr b="0" lang="ja-JP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グラフ 4" descr=""/>
          <p:cNvPicPr/>
          <p:nvPr/>
        </p:nvPicPr>
        <p:blipFill>
          <a:blip r:embed="rId1"/>
          <a:stretch/>
        </p:blipFill>
        <p:spPr>
          <a:xfrm>
            <a:off x="341280" y="652320"/>
            <a:ext cx="8461440" cy="4668840"/>
          </a:xfrm>
          <a:prstGeom prst="rect">
            <a:avLst/>
          </a:prstGeom>
          <a:ln w="0">
            <a:noFill/>
          </a:ln>
        </p:spPr>
      </p:pic>
      <p:sp>
        <p:nvSpPr>
          <p:cNvPr id="42" name="正方形/長方形 6"/>
          <p:cNvSpPr/>
          <p:nvPr/>
        </p:nvSpPr>
        <p:spPr>
          <a:xfrm>
            <a:off x="349200" y="5316480"/>
            <a:ext cx="84456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Calibri"/>
              </a:rPr>
              <a:t>Supplementary Figure S1 </a:t>
            </a: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Distributions of the SSR motifs of the CaES markers.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  <a:p>
            <a:pPr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Red, Green, and blue bars indicate the SSR motifs of di-, tri-, and tetranucleotide repeats. The numbers of SSR markers are shown at the top of the bars.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31T00:21:21Z</dcterms:created>
  <dc:creator>SHIRASAWA Kenta</dc:creator>
  <dc:description/>
  <dc:language>en-US</dc:language>
  <cp:lastModifiedBy>SHIRASAWA Kenta</cp:lastModifiedBy>
  <dcterms:modified xsi:type="dcterms:W3CDTF">2012-07-31T00:24:29Z</dcterms:modified>
  <cp:revision>1</cp:revision>
  <dc:subject/>
  <dc:title>スライド 1</dc:title>
</cp:coreProperties>
</file>